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856FA-B9F7-4DB0-BD57-19E7E1C4F3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4E9DE-A09E-407A-A449-FA42ECF1DF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25A7F-96D9-494B-82B8-A212416C9A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0C6B3-5657-44C2-ABB5-9A914C772A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5C2BA-76F0-4650-8799-21A6D149F4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5AED0-FFF6-4D97-A8BB-BD188B0B41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2BF2D-5692-4BF8-8F89-4035D26E3A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4F34DC-37B5-4D46-A951-F777C97C55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A4A89-7BAA-4FBC-8CB7-2CAF7D1CBE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FD824-C9A4-46DE-BFCA-346F03942F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54C1D-299D-4AD9-865C-D9F5C6306E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123CA-41BD-4FEA-871E-E1E6AF64AC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F8F170-AE40-42DB-98E1-4149F1FB1652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CAA1 MODIF"/>
          <p:cNvPicPr/>
          <p:nvPr/>
        </p:nvPicPr>
        <p:blipFill>
          <a:blip r:embed="rId1"/>
          <a:stretch/>
        </p:blipFill>
        <p:spPr>
          <a:xfrm>
            <a:off x="2050920" y="1424160"/>
            <a:ext cx="2818080" cy="2882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5" descr="TSBD2 detail AYE"/>
          <p:cNvPicPr/>
          <p:nvPr/>
        </p:nvPicPr>
        <p:blipFill>
          <a:blip r:embed="rId2"/>
          <a:stretch/>
        </p:blipFill>
        <p:spPr>
          <a:xfrm>
            <a:off x="1989000" y="5138640"/>
            <a:ext cx="2818080" cy="1741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 Box 6"/>
          <p:cNvSpPr/>
          <p:nvPr/>
        </p:nvSpPr>
        <p:spPr>
          <a:xfrm>
            <a:off x="1187280" y="1424160"/>
            <a:ext cx="43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1187280" y="5138640"/>
            <a:ext cx="43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9"/>
          <p:cNvSpPr/>
          <p:nvPr/>
        </p:nvSpPr>
        <p:spPr>
          <a:xfrm>
            <a:off x="549360" y="7278840"/>
            <a:ext cx="5832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Figure S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warming-like motility 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on the air-agarose interfac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of ATCC 17978 on TSBD plates (A) and AYE on CAA plates (B) after 24 h of growth at 37°C.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plates are representative of three independent experiments giving similar results.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12T16:36:22Z</dcterms:created>
  <dc:creator>VISCA2</dc:creator>
  <dc:description/>
  <dc:language>en-US</dc:language>
  <cp:lastModifiedBy>Checco</cp:lastModifiedBy>
  <dcterms:modified xsi:type="dcterms:W3CDTF">2011-05-11T14:05:01Z</dcterms:modified>
  <cp:revision>7</cp:revision>
  <dc:subject/>
  <dc:title>Diapositiva 1</dc:title>
</cp:coreProperties>
</file>